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11"/>
  </p:notesMasterIdLst>
  <p:sldIdLst>
    <p:sldId id="272" r:id="rId2"/>
    <p:sldId id="279" r:id="rId3"/>
    <p:sldId id="261" r:id="rId4"/>
    <p:sldId id="271" r:id="rId5"/>
    <p:sldId id="273" r:id="rId6"/>
    <p:sldId id="280" r:id="rId7"/>
    <p:sldId id="276" r:id="rId8"/>
    <p:sldId id="275" r:id="rId9"/>
    <p:sldId id="262" r:id="rId10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7CAD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465" autoAdjust="0"/>
    <p:restoredTop sz="94639" autoAdjust="0"/>
  </p:normalViewPr>
  <p:slideViewPr>
    <p:cSldViewPr snapToGrid="0">
      <p:cViewPr varScale="1">
        <p:scale>
          <a:sx n="31" d="100"/>
          <a:sy n="31" d="100"/>
        </p:scale>
        <p:origin x="2012" y="80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987088B-FD96-460F-902A-09A3572FDB3A}" type="datetimeFigureOut">
              <a:rPr lang="en-CA" smtClean="0"/>
              <a:t>2026-05-24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BB5D7A-4DEA-408B-BAC0-BBFE3A7E07D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826854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0BB5D7A-4DEA-408B-BAC0-BBFE3A7E07D2}" type="slidenum">
              <a:rPr lang="en-CA" smtClean="0"/>
              <a:t>4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8146325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0BB5D7A-4DEA-408B-BAC0-BBFE3A7E07D2}" type="slidenum">
              <a:rPr lang="en-CA" smtClean="0"/>
              <a:t>5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849226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98A122-62E1-48BC-AA14-B7B9A7E482C9}" type="datetimeFigureOut">
              <a:rPr lang="en-CA" smtClean="0"/>
              <a:t>2026-05-2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39223-BB4B-45F7-A091-F4F1D9A0DDB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165264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98A122-62E1-48BC-AA14-B7B9A7E482C9}" type="datetimeFigureOut">
              <a:rPr lang="en-CA" smtClean="0"/>
              <a:t>2026-05-2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39223-BB4B-45F7-A091-F4F1D9A0DDB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355025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98A122-62E1-48BC-AA14-B7B9A7E482C9}" type="datetimeFigureOut">
              <a:rPr lang="en-CA" smtClean="0"/>
              <a:t>2026-05-2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39223-BB4B-45F7-A091-F4F1D9A0DDB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978787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98A122-62E1-48BC-AA14-B7B9A7E482C9}" type="datetimeFigureOut">
              <a:rPr lang="en-CA" smtClean="0"/>
              <a:t>2026-05-2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39223-BB4B-45F7-A091-F4F1D9A0DDB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272011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82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82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98A122-62E1-48BC-AA14-B7B9A7E482C9}" type="datetimeFigureOut">
              <a:rPr lang="en-CA" smtClean="0"/>
              <a:t>2026-05-2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39223-BB4B-45F7-A091-F4F1D9A0DDB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975169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98A122-62E1-48BC-AA14-B7B9A7E482C9}" type="datetimeFigureOut">
              <a:rPr lang="en-CA" smtClean="0"/>
              <a:t>2026-05-2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39223-BB4B-45F7-A091-F4F1D9A0DDB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470717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98A122-62E1-48BC-AA14-B7B9A7E482C9}" type="datetimeFigureOut">
              <a:rPr lang="en-CA" smtClean="0"/>
              <a:t>2026-05-24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39223-BB4B-45F7-A091-F4F1D9A0DDB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611531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98A122-62E1-48BC-AA14-B7B9A7E482C9}" type="datetimeFigureOut">
              <a:rPr lang="en-CA" smtClean="0"/>
              <a:t>2026-05-24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39223-BB4B-45F7-A091-F4F1D9A0DDB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506994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98A122-62E1-48BC-AA14-B7B9A7E482C9}" type="datetimeFigureOut">
              <a:rPr lang="en-CA" smtClean="0"/>
              <a:t>2026-05-24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39223-BB4B-45F7-A091-F4F1D9A0DDB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721231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98A122-62E1-48BC-AA14-B7B9A7E482C9}" type="datetimeFigureOut">
              <a:rPr lang="en-CA" smtClean="0"/>
              <a:t>2026-05-2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39223-BB4B-45F7-A091-F4F1D9A0DDB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960634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98A122-62E1-48BC-AA14-B7B9A7E482C9}" type="datetimeFigureOut">
              <a:rPr lang="en-CA" smtClean="0"/>
              <a:t>2026-05-2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39223-BB4B-45F7-A091-F4F1D9A0DDB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723573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098A122-62E1-48BC-AA14-B7B9A7E482C9}" type="datetimeFigureOut">
              <a:rPr lang="en-CA" smtClean="0"/>
              <a:t>2026-05-2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3139223-BB4B-45F7-A091-F4F1D9A0DDB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38899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8.xml"/><Relationship Id="rId6" Type="http://schemas.openxmlformats.org/officeDocument/2006/relationships/image" Target="../media/image6.emf"/><Relationship Id="rId11" Type="http://schemas.openxmlformats.org/officeDocument/2006/relationships/image" Target="../media/image9.emf"/><Relationship Id="rId5" Type="http://schemas.openxmlformats.org/officeDocument/2006/relationships/oleObject" Target="../embeddings/oleObject2.bin"/><Relationship Id="rId10" Type="http://schemas.openxmlformats.org/officeDocument/2006/relationships/oleObject" Target="../embeddings/oleObject4.bin"/><Relationship Id="rId4" Type="http://schemas.openxmlformats.org/officeDocument/2006/relationships/image" Target="../media/image5.emf"/><Relationship Id="rId9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8.bin"/><Relationship Id="rId13" Type="http://schemas.openxmlformats.org/officeDocument/2006/relationships/image" Target="../media/image15.emf"/><Relationship Id="rId3" Type="http://schemas.openxmlformats.org/officeDocument/2006/relationships/image" Target="../media/image10.emf"/><Relationship Id="rId7" Type="http://schemas.openxmlformats.org/officeDocument/2006/relationships/image" Target="../media/image12.emf"/><Relationship Id="rId12" Type="http://schemas.openxmlformats.org/officeDocument/2006/relationships/oleObject" Target="../embeddings/oleObject10.bin"/><Relationship Id="rId17" Type="http://schemas.openxmlformats.org/officeDocument/2006/relationships/image" Target="../media/image17.emf"/><Relationship Id="rId2" Type="http://schemas.openxmlformats.org/officeDocument/2006/relationships/oleObject" Target="../embeddings/oleObject5.bin"/><Relationship Id="rId16" Type="http://schemas.openxmlformats.org/officeDocument/2006/relationships/oleObject" Target="../embeddings/oleObject12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7.bin"/><Relationship Id="rId11" Type="http://schemas.openxmlformats.org/officeDocument/2006/relationships/image" Target="../media/image14.emf"/><Relationship Id="rId5" Type="http://schemas.openxmlformats.org/officeDocument/2006/relationships/image" Target="../media/image11.emf"/><Relationship Id="rId15" Type="http://schemas.openxmlformats.org/officeDocument/2006/relationships/image" Target="../media/image16.emf"/><Relationship Id="rId10" Type="http://schemas.openxmlformats.org/officeDocument/2006/relationships/oleObject" Target="../embeddings/oleObject9.bin"/><Relationship Id="rId4" Type="http://schemas.openxmlformats.org/officeDocument/2006/relationships/oleObject" Target="../embeddings/oleObject6.bin"/><Relationship Id="rId9" Type="http://schemas.openxmlformats.org/officeDocument/2006/relationships/image" Target="../media/image13.emf"/><Relationship Id="rId14" Type="http://schemas.openxmlformats.org/officeDocument/2006/relationships/oleObject" Target="../embeddings/oleObject11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emf"/><Relationship Id="rId13" Type="http://schemas.openxmlformats.org/officeDocument/2006/relationships/oleObject" Target="../embeddings/oleObject18.bin"/><Relationship Id="rId18" Type="http://schemas.openxmlformats.org/officeDocument/2006/relationships/image" Target="../media/image25.emf"/><Relationship Id="rId3" Type="http://schemas.openxmlformats.org/officeDocument/2006/relationships/oleObject" Target="../embeddings/oleObject13.bin"/><Relationship Id="rId7" Type="http://schemas.openxmlformats.org/officeDocument/2006/relationships/oleObject" Target="../embeddings/oleObject15.bin"/><Relationship Id="rId12" Type="http://schemas.openxmlformats.org/officeDocument/2006/relationships/image" Target="../media/image22.emf"/><Relationship Id="rId17" Type="http://schemas.openxmlformats.org/officeDocument/2006/relationships/oleObject" Target="../embeddings/oleObject20.bin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24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emf"/><Relationship Id="rId11" Type="http://schemas.openxmlformats.org/officeDocument/2006/relationships/oleObject" Target="../embeddings/oleObject17.bin"/><Relationship Id="rId5" Type="http://schemas.openxmlformats.org/officeDocument/2006/relationships/oleObject" Target="../embeddings/oleObject14.bin"/><Relationship Id="rId15" Type="http://schemas.openxmlformats.org/officeDocument/2006/relationships/oleObject" Target="../embeddings/oleObject19.bin"/><Relationship Id="rId10" Type="http://schemas.openxmlformats.org/officeDocument/2006/relationships/image" Target="../media/image21.emf"/><Relationship Id="rId4" Type="http://schemas.openxmlformats.org/officeDocument/2006/relationships/image" Target="../media/image18.emf"/><Relationship Id="rId9" Type="http://schemas.openxmlformats.org/officeDocument/2006/relationships/oleObject" Target="../embeddings/oleObject16.bin"/><Relationship Id="rId14" Type="http://schemas.openxmlformats.org/officeDocument/2006/relationships/image" Target="../media/image23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emf"/><Relationship Id="rId3" Type="http://schemas.openxmlformats.org/officeDocument/2006/relationships/oleObject" Target="../embeddings/oleObject21.bin"/><Relationship Id="rId7" Type="http://schemas.openxmlformats.org/officeDocument/2006/relationships/oleObject" Target="../embeddings/oleObject23.bin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emf"/><Relationship Id="rId5" Type="http://schemas.openxmlformats.org/officeDocument/2006/relationships/oleObject" Target="../embeddings/oleObject22.bin"/><Relationship Id="rId10" Type="http://schemas.openxmlformats.org/officeDocument/2006/relationships/image" Target="../media/image29.emf"/><Relationship Id="rId4" Type="http://schemas.openxmlformats.org/officeDocument/2006/relationships/image" Target="../media/image26.emf"/><Relationship Id="rId9" Type="http://schemas.openxmlformats.org/officeDocument/2006/relationships/oleObject" Target="../embeddings/oleObject24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8.bin"/><Relationship Id="rId3" Type="http://schemas.openxmlformats.org/officeDocument/2006/relationships/image" Target="../media/image30.emf"/><Relationship Id="rId7" Type="http://schemas.openxmlformats.org/officeDocument/2006/relationships/image" Target="../media/image32.emf"/><Relationship Id="rId2" Type="http://schemas.openxmlformats.org/officeDocument/2006/relationships/oleObject" Target="../embeddings/oleObject25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27.bin"/><Relationship Id="rId5" Type="http://schemas.openxmlformats.org/officeDocument/2006/relationships/image" Target="../media/image31.emf"/><Relationship Id="rId4" Type="http://schemas.openxmlformats.org/officeDocument/2006/relationships/oleObject" Target="../embeddings/oleObject26.bin"/><Relationship Id="rId9" Type="http://schemas.openxmlformats.org/officeDocument/2006/relationships/image" Target="../media/image33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2.bin"/><Relationship Id="rId13" Type="http://schemas.openxmlformats.org/officeDocument/2006/relationships/image" Target="../media/image39.emf"/><Relationship Id="rId18" Type="http://schemas.openxmlformats.org/officeDocument/2006/relationships/oleObject" Target="../embeddings/oleObject37.bin"/><Relationship Id="rId3" Type="http://schemas.openxmlformats.org/officeDocument/2006/relationships/image" Target="../media/image34.emf"/><Relationship Id="rId21" Type="http://schemas.openxmlformats.org/officeDocument/2006/relationships/image" Target="../media/image43.emf"/><Relationship Id="rId7" Type="http://schemas.openxmlformats.org/officeDocument/2006/relationships/image" Target="../media/image36.emf"/><Relationship Id="rId12" Type="http://schemas.openxmlformats.org/officeDocument/2006/relationships/oleObject" Target="../embeddings/oleObject34.bin"/><Relationship Id="rId17" Type="http://schemas.openxmlformats.org/officeDocument/2006/relationships/image" Target="../media/image41.emf"/><Relationship Id="rId25" Type="http://schemas.openxmlformats.org/officeDocument/2006/relationships/image" Target="../media/image45.emf"/><Relationship Id="rId2" Type="http://schemas.openxmlformats.org/officeDocument/2006/relationships/oleObject" Target="../embeddings/oleObject29.bin"/><Relationship Id="rId16" Type="http://schemas.openxmlformats.org/officeDocument/2006/relationships/oleObject" Target="../embeddings/oleObject36.bin"/><Relationship Id="rId20" Type="http://schemas.openxmlformats.org/officeDocument/2006/relationships/oleObject" Target="../embeddings/oleObject38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1.bin"/><Relationship Id="rId11" Type="http://schemas.openxmlformats.org/officeDocument/2006/relationships/image" Target="../media/image38.emf"/><Relationship Id="rId24" Type="http://schemas.openxmlformats.org/officeDocument/2006/relationships/oleObject" Target="../embeddings/oleObject40.bin"/><Relationship Id="rId5" Type="http://schemas.openxmlformats.org/officeDocument/2006/relationships/image" Target="../media/image35.emf"/><Relationship Id="rId15" Type="http://schemas.openxmlformats.org/officeDocument/2006/relationships/image" Target="../media/image40.emf"/><Relationship Id="rId23" Type="http://schemas.openxmlformats.org/officeDocument/2006/relationships/image" Target="../media/image44.emf"/><Relationship Id="rId10" Type="http://schemas.openxmlformats.org/officeDocument/2006/relationships/oleObject" Target="../embeddings/oleObject33.bin"/><Relationship Id="rId19" Type="http://schemas.openxmlformats.org/officeDocument/2006/relationships/image" Target="../media/image42.emf"/><Relationship Id="rId4" Type="http://schemas.openxmlformats.org/officeDocument/2006/relationships/oleObject" Target="../embeddings/oleObject30.bin"/><Relationship Id="rId9" Type="http://schemas.openxmlformats.org/officeDocument/2006/relationships/image" Target="../media/image37.emf"/><Relationship Id="rId14" Type="http://schemas.openxmlformats.org/officeDocument/2006/relationships/oleObject" Target="../embeddings/oleObject35.bin"/><Relationship Id="rId22" Type="http://schemas.openxmlformats.org/officeDocument/2006/relationships/oleObject" Target="../embeddings/oleObject39.bin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4.bin"/><Relationship Id="rId13" Type="http://schemas.openxmlformats.org/officeDocument/2006/relationships/image" Target="../media/image51.emf"/><Relationship Id="rId3" Type="http://schemas.openxmlformats.org/officeDocument/2006/relationships/image" Target="../media/image46.emf"/><Relationship Id="rId7" Type="http://schemas.openxmlformats.org/officeDocument/2006/relationships/image" Target="../media/image48.emf"/><Relationship Id="rId12" Type="http://schemas.openxmlformats.org/officeDocument/2006/relationships/oleObject" Target="../embeddings/oleObject46.bin"/><Relationship Id="rId17" Type="http://schemas.openxmlformats.org/officeDocument/2006/relationships/image" Target="../media/image53.emf"/><Relationship Id="rId2" Type="http://schemas.openxmlformats.org/officeDocument/2006/relationships/oleObject" Target="../embeddings/oleObject41.bin"/><Relationship Id="rId16" Type="http://schemas.openxmlformats.org/officeDocument/2006/relationships/oleObject" Target="../embeddings/oleObject48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43.bin"/><Relationship Id="rId11" Type="http://schemas.openxmlformats.org/officeDocument/2006/relationships/image" Target="../media/image50.emf"/><Relationship Id="rId5" Type="http://schemas.openxmlformats.org/officeDocument/2006/relationships/image" Target="../media/image47.emf"/><Relationship Id="rId15" Type="http://schemas.openxmlformats.org/officeDocument/2006/relationships/image" Target="../media/image52.emf"/><Relationship Id="rId10" Type="http://schemas.openxmlformats.org/officeDocument/2006/relationships/oleObject" Target="../embeddings/oleObject45.bin"/><Relationship Id="rId4" Type="http://schemas.openxmlformats.org/officeDocument/2006/relationships/oleObject" Target="../embeddings/oleObject42.bin"/><Relationship Id="rId9" Type="http://schemas.openxmlformats.org/officeDocument/2006/relationships/image" Target="../media/image49.emf"/><Relationship Id="rId14" Type="http://schemas.openxmlformats.org/officeDocument/2006/relationships/oleObject" Target="../embeddings/oleObject47.bin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png"/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7.tiff"/><Relationship Id="rId4" Type="http://schemas.openxmlformats.org/officeDocument/2006/relationships/image" Target="../media/image5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07537A5-7037-9D1C-3B9A-9AB69738AF03}"/>
              </a:ext>
            </a:extLst>
          </p:cNvPr>
          <p:cNvSpPr txBox="1"/>
          <p:nvPr/>
        </p:nvSpPr>
        <p:spPr>
          <a:xfrm>
            <a:off x="4273638" y="793392"/>
            <a:ext cx="317849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3200" b="1" dirty="0"/>
              <a:t>SUPPLEMENTAL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CA9C27B-D080-8C40-4123-293ECE604A42}"/>
              </a:ext>
            </a:extLst>
          </p:cNvPr>
          <p:cNvSpPr txBox="1"/>
          <p:nvPr/>
        </p:nvSpPr>
        <p:spPr>
          <a:xfrm>
            <a:off x="1054346" y="15263533"/>
            <a:ext cx="16706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S1.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1170D8D3-0F22-C94F-48C1-EF23DDF4FB3A}"/>
              </a:ext>
            </a:extLst>
          </p:cNvPr>
          <p:cNvGrpSpPr/>
          <p:nvPr/>
        </p:nvGrpSpPr>
        <p:grpSpPr>
          <a:xfrm>
            <a:off x="6154633" y="1740336"/>
            <a:ext cx="3648916" cy="4730523"/>
            <a:chOff x="732641" y="1623729"/>
            <a:chExt cx="5650511" cy="6943158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58D3FBF9-5977-C87D-59D0-2583F174BEB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83" r="3262" b="4272"/>
            <a:stretch>
              <a:fillRect/>
            </a:stretch>
          </p:blipFill>
          <p:spPr>
            <a:xfrm>
              <a:off x="732641" y="1623729"/>
              <a:ext cx="5650511" cy="6943158"/>
            </a:xfrm>
            <a:prstGeom prst="rect">
              <a:avLst/>
            </a:prstGeom>
          </p:spPr>
        </p:pic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14ABE15E-6956-E1FF-7970-F362D55372E9}"/>
                </a:ext>
              </a:extLst>
            </p:cNvPr>
            <p:cNvSpPr/>
            <p:nvPr/>
          </p:nvSpPr>
          <p:spPr>
            <a:xfrm rot="1323719">
              <a:off x="3353027" y="1671679"/>
              <a:ext cx="604299" cy="814981"/>
            </a:xfrm>
            <a:prstGeom prst="rect">
              <a:avLst/>
            </a:prstGeom>
            <a:gradFill flip="none" rotWithShape="1">
              <a:gsLst>
                <a:gs pos="0">
                  <a:srgbClr val="C7CAD0">
                    <a:tint val="66000"/>
                    <a:satMod val="160000"/>
                  </a:srgbClr>
                </a:gs>
                <a:gs pos="50000">
                  <a:srgbClr val="C7CAD0">
                    <a:tint val="44500"/>
                    <a:satMod val="160000"/>
                  </a:srgbClr>
                </a:gs>
                <a:gs pos="100000">
                  <a:srgbClr val="C7CAD0">
                    <a:tint val="23500"/>
                    <a:satMod val="160000"/>
                  </a:srgbClr>
                </a:gs>
              </a:gsLst>
              <a:lin ang="108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dirty="0"/>
            </a:p>
          </p:txBody>
        </p:sp>
      </p:grpSp>
      <p:pic>
        <p:nvPicPr>
          <p:cNvPr id="13" name="Picture 12">
            <a:extLst>
              <a:ext uri="{FF2B5EF4-FFF2-40B4-BE49-F238E27FC236}">
                <a16:creationId xmlns:a16="http://schemas.microsoft.com/office/drawing/2014/main" id="{E5BC37AB-2BC9-021D-FDFA-33FC73242BF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873" r="3499" b="5353"/>
          <a:stretch>
            <a:fillRect/>
          </a:stretch>
        </p:blipFill>
        <p:spPr>
          <a:xfrm>
            <a:off x="1474059" y="1893765"/>
            <a:ext cx="4270482" cy="384001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798B901-EF1D-41F0-5324-59427ED197AB}"/>
              </a:ext>
            </a:extLst>
          </p:cNvPr>
          <p:cNvSpPr txBox="1"/>
          <p:nvPr/>
        </p:nvSpPr>
        <p:spPr>
          <a:xfrm>
            <a:off x="850604" y="1740336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35B3679-0332-FE6E-2CBB-3229758492A9}"/>
              </a:ext>
            </a:extLst>
          </p:cNvPr>
          <p:cNvSpPr txBox="1"/>
          <p:nvPr/>
        </p:nvSpPr>
        <p:spPr>
          <a:xfrm>
            <a:off x="850604" y="6400070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1" name="Picture 10" descr="The image depicts a flowchart illustrating various medical measurements and protocols, including echocardiography, cardiac photoacoustic imaging, haemodynamic monitoring, hypoxia challenges, adrenergic agonists, pulse oximetry, cardiac output correlation, induced supply-demand mismatch, and plasma collection in anaesthetized mice.&#10;&#10;AI-generated content may be incorrect.">
            <a:extLst>
              <a:ext uri="{FF2B5EF4-FFF2-40B4-BE49-F238E27FC236}">
                <a16:creationId xmlns:a16="http://schemas.microsoft.com/office/drawing/2014/main" id="{DFED7B03-A0A5-9CAC-3199-0984A403391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56" t="7824" r="4849" b="13280"/>
          <a:stretch>
            <a:fillRect/>
          </a:stretch>
        </p:blipFill>
        <p:spPr>
          <a:xfrm>
            <a:off x="1281540" y="6429353"/>
            <a:ext cx="9409517" cy="58588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551504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901BC91-0917-852B-8BD5-61FDAD68666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8" t="26754" r="7707" b="30330"/>
          <a:stretch>
            <a:fillRect/>
          </a:stretch>
        </p:blipFill>
        <p:spPr>
          <a:xfrm>
            <a:off x="1041728" y="3949463"/>
            <a:ext cx="9715168" cy="3352964"/>
          </a:xfrm>
          <a:prstGeom prst="rect">
            <a:avLst/>
          </a:prstGeom>
        </p:spPr>
      </p:pic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35F2E4C7-C3E1-AB72-5E64-DF3152744C7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29355063"/>
              </p:ext>
            </p:extLst>
          </p:nvPr>
        </p:nvGraphicFramePr>
        <p:xfrm>
          <a:off x="1102316" y="7522426"/>
          <a:ext cx="4503916" cy="33954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3" imgW="3258148" imgH="2455521" progId="Prism10.Document">
                  <p:embed/>
                </p:oleObj>
              </mc:Choice>
              <mc:Fallback>
                <p:oleObj name="Prism" r:id="rId3" imgW="3258148" imgH="2455521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1E286CDE-D922-3DD3-A065-F53AE3629CC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102316" y="7522426"/>
                        <a:ext cx="4503916" cy="339549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809FB151-DDEE-6CFF-E69B-F555CDB4B04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33421306"/>
              </p:ext>
            </p:extLst>
          </p:nvPr>
        </p:nvGraphicFramePr>
        <p:xfrm>
          <a:off x="5099258" y="7564958"/>
          <a:ext cx="3023521" cy="33529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5" imgW="2215195" imgH="2455521" progId="Prism10.Document">
                  <p:embed/>
                </p:oleObj>
              </mc:Choice>
              <mc:Fallback>
                <p:oleObj name="Prism" r:id="rId5" imgW="2215195" imgH="2455521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7CDA8AAE-69E0-8871-7F20-0854F643430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099258" y="7564958"/>
                        <a:ext cx="3023521" cy="33529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5B4C1F96-B8BF-F428-6E56-4E35113EA1C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0156552"/>
              </p:ext>
            </p:extLst>
          </p:nvPr>
        </p:nvGraphicFramePr>
        <p:xfrm>
          <a:off x="7678154" y="7564958"/>
          <a:ext cx="3023521" cy="33529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7" imgW="2215195" imgH="2455521" progId="Prism10.Document">
                  <p:embed/>
                </p:oleObj>
              </mc:Choice>
              <mc:Fallback>
                <p:oleObj name="Prism" r:id="rId7" imgW="2215195" imgH="2455521" progId="Prism10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5B4C1F96-B8BF-F428-6E56-4E35113EA1C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678154" y="7564958"/>
                        <a:ext cx="3023521" cy="33529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C34D87D8-E268-ADF0-05FC-6C79D70D6FC7}"/>
              </a:ext>
            </a:extLst>
          </p:cNvPr>
          <p:cNvSpPr txBox="1"/>
          <p:nvPr/>
        </p:nvSpPr>
        <p:spPr>
          <a:xfrm>
            <a:off x="1109411" y="15467372"/>
            <a:ext cx="16706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S2.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F3D5DBE-03F6-639C-4E1A-C42C2564983F}"/>
              </a:ext>
            </a:extLst>
          </p:cNvPr>
          <p:cNvSpPr txBox="1"/>
          <p:nvPr/>
        </p:nvSpPr>
        <p:spPr>
          <a:xfrm>
            <a:off x="1109411" y="1119896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B5298B0-A099-F603-4F89-1E0ED934A84C}"/>
              </a:ext>
            </a:extLst>
          </p:cNvPr>
          <p:cNvSpPr txBox="1"/>
          <p:nvPr/>
        </p:nvSpPr>
        <p:spPr>
          <a:xfrm>
            <a:off x="1109411" y="3940366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FFEE73E-27C2-387A-98CD-D8DEBB8F453D}"/>
              </a:ext>
            </a:extLst>
          </p:cNvPr>
          <p:cNvSpPr txBox="1"/>
          <p:nvPr/>
        </p:nvSpPr>
        <p:spPr>
          <a:xfrm>
            <a:off x="4506750" y="315411"/>
            <a:ext cx="317849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3200" b="1" dirty="0"/>
              <a:t>SUPPLEMENTA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4059EBA-613B-F6B4-6DEE-6B7356DBA3D0}"/>
              </a:ext>
            </a:extLst>
          </p:cNvPr>
          <p:cNvSpPr txBox="1"/>
          <p:nvPr/>
        </p:nvSpPr>
        <p:spPr>
          <a:xfrm>
            <a:off x="5024106" y="7295862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949E6D0-1BFC-EDF0-4BAE-01B353EE79A7}"/>
              </a:ext>
            </a:extLst>
          </p:cNvPr>
          <p:cNvSpPr txBox="1"/>
          <p:nvPr/>
        </p:nvSpPr>
        <p:spPr>
          <a:xfrm>
            <a:off x="1130193" y="7295862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4" name="Picture 3" descr="HF&#10;&#10;AI-generated content may be incorrect.">
            <a:extLst>
              <a:ext uri="{FF2B5EF4-FFF2-40B4-BE49-F238E27FC236}">
                <a16:creationId xmlns:a16="http://schemas.microsoft.com/office/drawing/2014/main" id="{95DB40DA-BCD8-88A7-DD67-15FAA63E47B6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00" t="29822" r="8123" b="36052"/>
          <a:stretch>
            <a:fillRect/>
          </a:stretch>
        </p:blipFill>
        <p:spPr>
          <a:xfrm>
            <a:off x="1146235" y="1501351"/>
            <a:ext cx="9748654" cy="2763221"/>
          </a:xfrm>
          <a:prstGeom prst="rect">
            <a:avLst/>
          </a:prstGeom>
        </p:spPr>
      </p:pic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BE668167-C6E1-4955-36FC-FF17046E83A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57625690"/>
              </p:ext>
            </p:extLst>
          </p:nvPr>
        </p:nvGraphicFramePr>
        <p:xfrm>
          <a:off x="1219200" y="11239500"/>
          <a:ext cx="3805238" cy="3557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10" imgW="2908816" imgH="2717636" progId="Prism10.Document">
                  <p:embed/>
                </p:oleObj>
              </mc:Choice>
              <mc:Fallback>
                <p:oleObj name="Prism" r:id="rId10" imgW="2908816" imgH="271763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219200" y="11239500"/>
                        <a:ext cx="3805238" cy="3557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43404A8D-B9C5-A5A1-A52A-C78DC5045798}"/>
              </a:ext>
            </a:extLst>
          </p:cNvPr>
          <p:cNvSpPr txBox="1"/>
          <p:nvPr/>
        </p:nvSpPr>
        <p:spPr>
          <a:xfrm>
            <a:off x="1130193" y="11130570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39129101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46B9A7B3-336C-4A7E-7319-9F170FD0FA8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8080008"/>
              </p:ext>
            </p:extLst>
          </p:nvPr>
        </p:nvGraphicFramePr>
        <p:xfrm>
          <a:off x="683044" y="11572699"/>
          <a:ext cx="5535779" cy="38978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2" imgW="3814557" imgH="2685592" progId="Prism10.Document">
                  <p:embed/>
                </p:oleObj>
              </mc:Choice>
              <mc:Fallback>
                <p:oleObj name="Prism" r:id="rId2" imgW="3814557" imgH="2685592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83044" y="11572699"/>
                        <a:ext cx="5535779" cy="38978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41960B09-184A-D0F1-64AA-45618912E13A}"/>
              </a:ext>
            </a:extLst>
          </p:cNvPr>
          <p:cNvSpPr txBox="1"/>
          <p:nvPr/>
        </p:nvSpPr>
        <p:spPr>
          <a:xfrm>
            <a:off x="4295210" y="188963"/>
            <a:ext cx="326185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3200" b="1" dirty="0"/>
              <a:t>SUPPLEMENTAL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3C199BA-F6B5-6813-AA6B-0754A74371D7}"/>
              </a:ext>
            </a:extLst>
          </p:cNvPr>
          <p:cNvSpPr txBox="1"/>
          <p:nvPr/>
        </p:nvSpPr>
        <p:spPr>
          <a:xfrm>
            <a:off x="508981" y="15552273"/>
            <a:ext cx="16706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S3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380C01F-E5CD-7A6F-2C54-52EA6AC1B768}"/>
              </a:ext>
            </a:extLst>
          </p:cNvPr>
          <p:cNvSpPr txBox="1"/>
          <p:nvPr/>
        </p:nvSpPr>
        <p:spPr>
          <a:xfrm>
            <a:off x="586428" y="804016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8B3FE9A-718C-3F1F-5530-7F846963760A}"/>
              </a:ext>
            </a:extLst>
          </p:cNvPr>
          <p:cNvSpPr txBox="1"/>
          <p:nvPr/>
        </p:nvSpPr>
        <p:spPr>
          <a:xfrm>
            <a:off x="562779" y="4275305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ADEEA7C-8E77-F9C0-2839-98574196697B}"/>
              </a:ext>
            </a:extLst>
          </p:cNvPr>
          <p:cNvSpPr txBox="1"/>
          <p:nvPr/>
        </p:nvSpPr>
        <p:spPr>
          <a:xfrm>
            <a:off x="586428" y="7702357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7E91B71-D798-2664-E176-BD02ED25B723}"/>
              </a:ext>
            </a:extLst>
          </p:cNvPr>
          <p:cNvSpPr txBox="1"/>
          <p:nvPr/>
        </p:nvSpPr>
        <p:spPr>
          <a:xfrm>
            <a:off x="629007" y="11511758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E72FFFC3-BAA4-7982-A0A8-92A0F78F1C1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4283993"/>
              </p:ext>
            </p:extLst>
          </p:nvPr>
        </p:nvGraphicFramePr>
        <p:xfrm>
          <a:off x="683044" y="7749727"/>
          <a:ext cx="5440739" cy="38549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4" imgW="3791509" imgH="2685592" progId="Prism10.Document">
                  <p:embed/>
                </p:oleObj>
              </mc:Choice>
              <mc:Fallback>
                <p:oleObj name="Prism" r:id="rId4" imgW="3791509" imgH="2685592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83044" y="7749727"/>
                        <a:ext cx="5440739" cy="38549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AB9DAFCE-39FC-5C36-842D-7CB512C7C3D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59855306"/>
              </p:ext>
            </p:extLst>
          </p:nvPr>
        </p:nvGraphicFramePr>
        <p:xfrm>
          <a:off x="5466820" y="7773256"/>
          <a:ext cx="5773381" cy="38549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6" imgW="4023436" imgH="2685592" progId="Prism10.Document">
                  <p:embed/>
                </p:oleObj>
              </mc:Choice>
              <mc:Fallback>
                <p:oleObj name="Prism" r:id="rId6" imgW="4023436" imgH="2685592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466820" y="7773256"/>
                        <a:ext cx="5773381" cy="38549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C30B7212-A204-ADE5-9617-99F011DA6F9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75366450"/>
              </p:ext>
            </p:extLst>
          </p:nvPr>
        </p:nvGraphicFramePr>
        <p:xfrm>
          <a:off x="5559462" y="11491334"/>
          <a:ext cx="5704283" cy="39643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8" imgW="4018754" imgH="2792166" progId="Prism10.Document">
                  <p:embed/>
                </p:oleObj>
              </mc:Choice>
              <mc:Fallback>
                <p:oleObj name="Prism" r:id="rId8" imgW="4018754" imgH="279216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559462" y="11491334"/>
                        <a:ext cx="5704283" cy="39643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5BA34D99-3258-771D-FAD2-817C91C9E24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28657246"/>
              </p:ext>
            </p:extLst>
          </p:nvPr>
        </p:nvGraphicFramePr>
        <p:xfrm>
          <a:off x="766521" y="4258763"/>
          <a:ext cx="5006181" cy="35930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10" imgW="3825001" imgH="2744999" progId="Prism10.Document">
                  <p:embed/>
                </p:oleObj>
              </mc:Choice>
              <mc:Fallback>
                <p:oleObj name="Prism" r:id="rId10" imgW="3825001" imgH="2744999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766521" y="4258763"/>
                        <a:ext cx="5006181" cy="35930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8C56D25D-0AA2-2D84-B7A1-379A5838570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3147038"/>
              </p:ext>
            </p:extLst>
          </p:nvPr>
        </p:nvGraphicFramePr>
        <p:xfrm>
          <a:off x="678236" y="750004"/>
          <a:ext cx="5069567" cy="35470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12" imgW="3848050" imgH="2691712" progId="Prism10.Document">
                  <p:embed/>
                </p:oleObj>
              </mc:Choice>
              <mc:Fallback>
                <p:oleObj name="Prism" r:id="rId12" imgW="3848050" imgH="2691712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678236" y="750004"/>
                        <a:ext cx="5069567" cy="35470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8F0F18BF-C055-E431-B62A-46A33C0E2B2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01801921"/>
              </p:ext>
            </p:extLst>
          </p:nvPr>
        </p:nvGraphicFramePr>
        <p:xfrm>
          <a:off x="5441463" y="675067"/>
          <a:ext cx="5388252" cy="36133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14" imgW="4029559" imgH="2702514" progId="Prism10.Document">
                  <p:embed/>
                </p:oleObj>
              </mc:Choice>
              <mc:Fallback>
                <p:oleObj name="Prism" r:id="rId14" imgW="4029559" imgH="2702514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5441463" y="675067"/>
                        <a:ext cx="5388252" cy="36133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5FC2391A-D075-17AC-DAB8-F4662C4F754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20139798"/>
              </p:ext>
            </p:extLst>
          </p:nvPr>
        </p:nvGraphicFramePr>
        <p:xfrm>
          <a:off x="5441462" y="4268711"/>
          <a:ext cx="5388252" cy="35737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16" imgW="4035681" imgH="2676590" progId="Prism10.Document">
                  <p:embed/>
                </p:oleObj>
              </mc:Choice>
              <mc:Fallback>
                <p:oleObj name="Prism" r:id="rId16" imgW="4035681" imgH="2676590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5441462" y="4268711"/>
                        <a:ext cx="5388252" cy="357379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11901438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D824C0B1-591C-B4C6-96F5-70078E650AEF}"/>
              </a:ext>
            </a:extLst>
          </p:cNvPr>
          <p:cNvSpPr txBox="1"/>
          <p:nvPr/>
        </p:nvSpPr>
        <p:spPr>
          <a:xfrm>
            <a:off x="4322732" y="341063"/>
            <a:ext cx="317849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3200" b="1" dirty="0"/>
              <a:t>SUPPLEMENTAL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4A45D59-C61C-7399-73C0-9AE504BC1830}"/>
              </a:ext>
            </a:extLst>
          </p:cNvPr>
          <p:cNvSpPr txBox="1"/>
          <p:nvPr/>
        </p:nvSpPr>
        <p:spPr>
          <a:xfrm>
            <a:off x="943049" y="14837490"/>
            <a:ext cx="16706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S4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CCF3BAC-B4A1-D51D-4E87-4FA60C6FF7DA}"/>
              </a:ext>
            </a:extLst>
          </p:cNvPr>
          <p:cNvSpPr txBox="1"/>
          <p:nvPr/>
        </p:nvSpPr>
        <p:spPr>
          <a:xfrm>
            <a:off x="602706" y="1434065"/>
            <a:ext cx="3680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1434706-2E3F-46FD-2FE3-93C684034EC9}"/>
              </a:ext>
            </a:extLst>
          </p:cNvPr>
          <p:cNvSpPr txBox="1"/>
          <p:nvPr/>
        </p:nvSpPr>
        <p:spPr>
          <a:xfrm>
            <a:off x="5834292" y="1434066"/>
            <a:ext cx="3680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A560927-B06D-6B0A-D035-BC6F90F930DF}"/>
              </a:ext>
            </a:extLst>
          </p:cNvPr>
          <p:cNvSpPr txBox="1"/>
          <p:nvPr/>
        </p:nvSpPr>
        <p:spPr>
          <a:xfrm>
            <a:off x="575014" y="8623332"/>
            <a:ext cx="3680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0B58D93-A512-00F1-16F4-3737A127935B}"/>
              </a:ext>
            </a:extLst>
          </p:cNvPr>
          <p:cNvSpPr txBox="1"/>
          <p:nvPr/>
        </p:nvSpPr>
        <p:spPr>
          <a:xfrm>
            <a:off x="6248778" y="8623332"/>
            <a:ext cx="3680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C4D5F2E9-CBC1-E0C4-DF9E-F37C89280E0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71724281"/>
              </p:ext>
            </p:extLst>
          </p:nvPr>
        </p:nvGraphicFramePr>
        <p:xfrm>
          <a:off x="6202363" y="8669338"/>
          <a:ext cx="3203575" cy="3822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3" imgW="2975801" imgH="3551505" progId="Prism10.Document">
                  <p:embed/>
                </p:oleObj>
              </mc:Choice>
              <mc:Fallback>
                <p:oleObj name="Prism" r:id="rId3" imgW="2975801" imgH="355150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202363" y="8669338"/>
                        <a:ext cx="3203575" cy="3822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D2617EBF-8AB5-8B88-D947-0F98BC1A502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59778528"/>
              </p:ext>
            </p:extLst>
          </p:nvPr>
        </p:nvGraphicFramePr>
        <p:xfrm>
          <a:off x="458788" y="8553450"/>
          <a:ext cx="3265487" cy="39512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5" imgW="2975801" imgH="3603352" progId="Prism10.Document">
                  <p:embed/>
                </p:oleObj>
              </mc:Choice>
              <mc:Fallback>
                <p:oleObj name="Prism" r:id="rId5" imgW="2975801" imgH="3603352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58788" y="8553450"/>
                        <a:ext cx="3265487" cy="39512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138CEBF7-A4FA-9FC8-3F0C-016D32C8810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00634359"/>
              </p:ext>
            </p:extLst>
          </p:nvPr>
        </p:nvGraphicFramePr>
        <p:xfrm>
          <a:off x="457116" y="1525822"/>
          <a:ext cx="5346656" cy="36495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7" imgW="3921158" imgH="2676590" progId="Prism10.Document">
                  <p:embed/>
                </p:oleObj>
              </mc:Choice>
              <mc:Fallback>
                <p:oleObj name="Prism" r:id="rId7" imgW="3921158" imgH="2676590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57116" y="1525822"/>
                        <a:ext cx="5346656" cy="36495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0BF74198-B5C1-2194-48D4-791819AC260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63177778"/>
              </p:ext>
            </p:extLst>
          </p:nvPr>
        </p:nvGraphicFramePr>
        <p:xfrm>
          <a:off x="5803772" y="1484657"/>
          <a:ext cx="5417487" cy="36907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9" imgW="3915035" imgH="2667229" progId="Prism10.Document">
                  <p:embed/>
                </p:oleObj>
              </mc:Choice>
              <mc:Fallback>
                <p:oleObj name="Prism" r:id="rId9" imgW="3915035" imgH="2667229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803772" y="1484657"/>
                        <a:ext cx="5417487" cy="36907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C0BA9922-E494-B09D-43D9-243DE2CF518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84696787"/>
              </p:ext>
            </p:extLst>
          </p:nvPr>
        </p:nvGraphicFramePr>
        <p:xfrm>
          <a:off x="3266275" y="8995636"/>
          <a:ext cx="3242592" cy="36273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11" imgW="2916379" imgH="3261667" progId="Prism10.Document">
                  <p:embed/>
                </p:oleObj>
              </mc:Choice>
              <mc:Fallback>
                <p:oleObj name="Prism" r:id="rId11" imgW="2916379" imgH="3261667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266275" y="8995636"/>
                        <a:ext cx="3242592" cy="362739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18">
            <a:extLst>
              <a:ext uri="{FF2B5EF4-FFF2-40B4-BE49-F238E27FC236}">
                <a16:creationId xmlns:a16="http://schemas.microsoft.com/office/drawing/2014/main" id="{B1A2364F-0188-67D7-AF42-3EDADB886C3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70449905"/>
              </p:ext>
            </p:extLst>
          </p:nvPr>
        </p:nvGraphicFramePr>
        <p:xfrm>
          <a:off x="8945355" y="9008763"/>
          <a:ext cx="3099245" cy="3495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13" imgW="2901253" imgH="3273909" progId="Prism10.Document">
                  <p:embed/>
                </p:oleObj>
              </mc:Choice>
              <mc:Fallback>
                <p:oleObj name="Prism" r:id="rId13" imgW="2901253" imgH="3273909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8945355" y="9008763"/>
                        <a:ext cx="3099245" cy="3495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id="{1A5861E2-706B-84EE-83F1-A2D08C881D5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51327560"/>
              </p:ext>
            </p:extLst>
          </p:nvPr>
        </p:nvGraphicFramePr>
        <p:xfrm>
          <a:off x="550901" y="4914246"/>
          <a:ext cx="5266207" cy="36309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15" imgW="3895228" imgH="2685592" progId="Prism10.Document">
                  <p:embed/>
                </p:oleObj>
              </mc:Choice>
              <mc:Fallback>
                <p:oleObj name="Prism" r:id="rId15" imgW="3895228" imgH="2685592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550901" y="4914246"/>
                        <a:ext cx="5266207" cy="363097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246832B7-A942-4028-378C-A42921D9751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67404855"/>
              </p:ext>
            </p:extLst>
          </p:nvPr>
        </p:nvGraphicFramePr>
        <p:xfrm>
          <a:off x="5886080" y="4879496"/>
          <a:ext cx="5335179" cy="36532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17" imgW="3892347" imgH="2665789" progId="Prism10.Document">
                  <p:embed/>
                </p:oleObj>
              </mc:Choice>
              <mc:Fallback>
                <p:oleObj name="Prism" r:id="rId17" imgW="3892347" imgH="2665789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5886080" y="4879496"/>
                        <a:ext cx="5335179" cy="36532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6232967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91022114-C168-CF08-8347-CE6630B42F4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90989718"/>
              </p:ext>
            </p:extLst>
          </p:nvPr>
        </p:nvGraphicFramePr>
        <p:xfrm>
          <a:off x="523821" y="1536735"/>
          <a:ext cx="6000559" cy="40813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3" imgW="3921158" imgH="2667229" progId="Prism10.Document">
                  <p:embed/>
                </p:oleObj>
              </mc:Choice>
              <mc:Fallback>
                <p:oleObj name="Prism" r:id="rId3" imgW="3921158" imgH="2667229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23821" y="1536735"/>
                        <a:ext cx="6000559" cy="40813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2067B235-67E3-4F47-694E-ECA36EEBBC0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00743603"/>
              </p:ext>
            </p:extLst>
          </p:nvPr>
        </p:nvGraphicFramePr>
        <p:xfrm>
          <a:off x="6050613" y="1549166"/>
          <a:ext cx="5853196" cy="40751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5" imgW="3866417" imgH="2693153" progId="Prism10.Document">
                  <p:embed/>
                </p:oleObj>
              </mc:Choice>
              <mc:Fallback>
                <p:oleObj name="Prism" r:id="rId5" imgW="3866417" imgH="2693153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050613" y="1549166"/>
                        <a:ext cx="5853196" cy="40751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8AD92B0D-D566-4078-B68C-3D07878BEA90}"/>
              </a:ext>
            </a:extLst>
          </p:cNvPr>
          <p:cNvSpPr txBox="1"/>
          <p:nvPr/>
        </p:nvSpPr>
        <p:spPr>
          <a:xfrm>
            <a:off x="4397891" y="589582"/>
            <a:ext cx="317849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3200" b="1" dirty="0"/>
              <a:t>SUPPLEMENTAL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3C76AF6-3AEC-B121-74B6-444555F1D977}"/>
              </a:ext>
            </a:extLst>
          </p:cNvPr>
          <p:cNvSpPr txBox="1"/>
          <p:nvPr/>
        </p:nvSpPr>
        <p:spPr>
          <a:xfrm>
            <a:off x="1258371" y="14440980"/>
            <a:ext cx="16706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S5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04AF496-2B6D-3902-69EF-61BF8728A892}"/>
              </a:ext>
            </a:extLst>
          </p:cNvPr>
          <p:cNvSpPr txBox="1"/>
          <p:nvPr/>
        </p:nvSpPr>
        <p:spPr>
          <a:xfrm>
            <a:off x="586428" y="1450783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2FC8726-05D2-AACC-DB99-68F484FCC105}"/>
              </a:ext>
            </a:extLst>
          </p:cNvPr>
          <p:cNvSpPr txBox="1"/>
          <p:nvPr/>
        </p:nvSpPr>
        <p:spPr>
          <a:xfrm>
            <a:off x="6067076" y="1450782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6E32498-1D5F-E6D2-9976-6377F90FA0A0}"/>
              </a:ext>
            </a:extLst>
          </p:cNvPr>
          <p:cNvSpPr txBox="1"/>
          <p:nvPr/>
        </p:nvSpPr>
        <p:spPr>
          <a:xfrm>
            <a:off x="621073" y="5543250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91AAD93-D470-9B1C-81F6-2F709EC670EB}"/>
              </a:ext>
            </a:extLst>
          </p:cNvPr>
          <p:cNvSpPr txBox="1"/>
          <p:nvPr/>
        </p:nvSpPr>
        <p:spPr>
          <a:xfrm>
            <a:off x="6147865" y="5469391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60A506F6-4294-67CF-AF53-8A885ED21D4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24486661"/>
              </p:ext>
            </p:extLst>
          </p:nvPr>
        </p:nvGraphicFramePr>
        <p:xfrm>
          <a:off x="6116782" y="5713968"/>
          <a:ext cx="5522521" cy="43630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7" imgW="3893787" imgH="3075883" progId="Prism10.Document">
                  <p:embed/>
                </p:oleObj>
              </mc:Choice>
              <mc:Fallback>
                <p:oleObj name="Prism" r:id="rId7" imgW="3893787" imgH="3075883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116782" y="5713968"/>
                        <a:ext cx="5522521" cy="43630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71F98A92-8479-E57C-EFA8-7387885DD39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00825809"/>
              </p:ext>
            </p:extLst>
          </p:nvPr>
        </p:nvGraphicFramePr>
        <p:xfrm>
          <a:off x="692467" y="5619327"/>
          <a:ext cx="5580137" cy="45237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9" imgW="3890546" imgH="3153653" progId="Prism10.Document">
                  <p:embed/>
                </p:oleObj>
              </mc:Choice>
              <mc:Fallback>
                <p:oleObj name="Prism" r:id="rId9" imgW="3890546" imgH="3153653" progId="Prism10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9E15538A-E235-E0BA-F3B0-D38985B50EE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92467" y="5619327"/>
                        <a:ext cx="5580137" cy="452375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27866685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4606DC3B-5D91-07D6-E1D0-EB0C114BD9FA}"/>
              </a:ext>
            </a:extLst>
          </p:cNvPr>
          <p:cNvSpPr txBox="1"/>
          <p:nvPr/>
        </p:nvSpPr>
        <p:spPr>
          <a:xfrm>
            <a:off x="1375690" y="1339065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A6A92FE-47DF-AC2D-7C85-C245E83C1BE2}"/>
              </a:ext>
            </a:extLst>
          </p:cNvPr>
          <p:cNvSpPr txBox="1"/>
          <p:nvPr/>
        </p:nvSpPr>
        <p:spPr>
          <a:xfrm>
            <a:off x="5139439" y="1339065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EB39911-8E5E-3691-19A1-BDE317E348C6}"/>
              </a:ext>
            </a:extLst>
          </p:cNvPr>
          <p:cNvSpPr txBox="1"/>
          <p:nvPr/>
        </p:nvSpPr>
        <p:spPr>
          <a:xfrm>
            <a:off x="1340937" y="5641856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6A9E804-B8B9-B00A-2F93-F9E8EFF7E71C}"/>
              </a:ext>
            </a:extLst>
          </p:cNvPr>
          <p:cNvSpPr txBox="1"/>
          <p:nvPr/>
        </p:nvSpPr>
        <p:spPr>
          <a:xfrm>
            <a:off x="5180723" y="5641856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3C8DD67-E58D-CD22-15CF-54DAE714E272}"/>
              </a:ext>
            </a:extLst>
          </p:cNvPr>
          <p:cNvSpPr txBox="1"/>
          <p:nvPr/>
        </p:nvSpPr>
        <p:spPr>
          <a:xfrm>
            <a:off x="2570867" y="1290294"/>
            <a:ext cx="1774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>
                <a:latin typeface="Arial" panose="020B0604020202020204" pitchFamily="34" charset="0"/>
                <a:cs typeface="Arial" panose="020B0604020202020204" pitchFamily="34" charset="0"/>
              </a:rPr>
              <a:t>Phenylephrin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0C72148-35E9-F633-E465-CA378BD2A433}"/>
              </a:ext>
            </a:extLst>
          </p:cNvPr>
          <p:cNvSpPr txBox="1"/>
          <p:nvPr/>
        </p:nvSpPr>
        <p:spPr>
          <a:xfrm>
            <a:off x="6479624" y="1727597"/>
            <a:ext cx="15440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>
                <a:latin typeface="Arial" panose="020B0604020202020204" pitchFamily="34" charset="0"/>
                <a:cs typeface="Arial" panose="020B0604020202020204" pitchFamily="34" charset="0"/>
              </a:rPr>
              <a:t>Isoprenalin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812B0D3-3BFF-08AC-4063-1DB66E0EF8BB}"/>
              </a:ext>
            </a:extLst>
          </p:cNvPr>
          <p:cNvSpPr txBox="1"/>
          <p:nvPr/>
        </p:nvSpPr>
        <p:spPr>
          <a:xfrm>
            <a:off x="2627782" y="5734189"/>
            <a:ext cx="17363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>
                <a:latin typeface="Arial" panose="020B0604020202020204" pitchFamily="34" charset="0"/>
                <a:cs typeface="Arial" panose="020B0604020202020204" pitchFamily="34" charset="0"/>
              </a:rPr>
              <a:t>Noradrenalin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BDA3F06-E9ED-2C8C-4A18-2F726C2D3772}"/>
              </a:ext>
            </a:extLst>
          </p:cNvPr>
          <p:cNvSpPr txBox="1"/>
          <p:nvPr/>
        </p:nvSpPr>
        <p:spPr>
          <a:xfrm>
            <a:off x="6065695" y="5786489"/>
            <a:ext cx="25955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>
                <a:latin typeface="Arial" panose="020B0604020202020204" pitchFamily="34" charset="0"/>
                <a:cs typeface="Arial" panose="020B0604020202020204" pitchFamily="34" charset="0"/>
              </a:rPr>
              <a:t>Sodium Nitroprussid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12BBEA9-5C88-5AA4-DF9A-E4C44DB05DC5}"/>
              </a:ext>
            </a:extLst>
          </p:cNvPr>
          <p:cNvSpPr txBox="1"/>
          <p:nvPr/>
        </p:nvSpPr>
        <p:spPr>
          <a:xfrm>
            <a:off x="1258371" y="14440980"/>
            <a:ext cx="16706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S6.</a:t>
            </a:r>
          </a:p>
        </p:txBody>
      </p:sp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7ECE58BA-28F1-0601-7EEE-65F9040B69B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24031376"/>
              </p:ext>
            </p:extLst>
          </p:nvPr>
        </p:nvGraphicFramePr>
        <p:xfrm>
          <a:off x="1519063" y="1469348"/>
          <a:ext cx="3900093" cy="40449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2" imgW="2907376" imgH="3015035" progId="Prism10.Document">
                  <p:embed/>
                </p:oleObj>
              </mc:Choice>
              <mc:Fallback>
                <p:oleObj name="Prism" r:id="rId2" imgW="2907376" imgH="3015035" progId="Prism10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7ECE58BA-28F1-0601-7EEE-65F9040B69B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519063" y="1469348"/>
                        <a:ext cx="3900093" cy="40449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Object 27">
            <a:extLst>
              <a:ext uri="{FF2B5EF4-FFF2-40B4-BE49-F238E27FC236}">
                <a16:creationId xmlns:a16="http://schemas.microsoft.com/office/drawing/2014/main" id="{4FF1F17C-D254-41F6-BD48-A72AD635F03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55653831"/>
              </p:ext>
            </p:extLst>
          </p:nvPr>
        </p:nvGraphicFramePr>
        <p:xfrm>
          <a:off x="5375265" y="1928960"/>
          <a:ext cx="3848982" cy="35525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4" imgW="2907376" imgH="2682711" progId="Prism10.Document">
                  <p:embed/>
                </p:oleObj>
              </mc:Choice>
              <mc:Fallback>
                <p:oleObj name="Prism" r:id="rId4" imgW="2907376" imgH="2682711" progId="Prism10.Document">
                  <p:embed/>
                  <p:pic>
                    <p:nvPicPr>
                      <p:cNvPr id="28" name="Object 27">
                        <a:extLst>
                          <a:ext uri="{FF2B5EF4-FFF2-40B4-BE49-F238E27FC236}">
                            <a16:creationId xmlns:a16="http://schemas.microsoft.com/office/drawing/2014/main" id="{4FF1F17C-D254-41F6-BD48-A72AD635F03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375265" y="1928960"/>
                        <a:ext cx="3848982" cy="35525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Object 28">
            <a:extLst>
              <a:ext uri="{FF2B5EF4-FFF2-40B4-BE49-F238E27FC236}">
                <a16:creationId xmlns:a16="http://schemas.microsoft.com/office/drawing/2014/main" id="{2E5130AA-1975-3B54-0813-139B42E6C83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63895363"/>
              </p:ext>
            </p:extLst>
          </p:nvPr>
        </p:nvGraphicFramePr>
        <p:xfrm>
          <a:off x="1470936" y="5991227"/>
          <a:ext cx="4082599" cy="37682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6" imgW="2907376" imgH="2682711" progId="Prism10.Document">
                  <p:embed/>
                </p:oleObj>
              </mc:Choice>
              <mc:Fallback>
                <p:oleObj name="Prism" r:id="rId6" imgW="2907376" imgH="2682711" progId="Prism10.Document">
                  <p:embed/>
                  <p:pic>
                    <p:nvPicPr>
                      <p:cNvPr id="29" name="Object 28">
                        <a:extLst>
                          <a:ext uri="{FF2B5EF4-FFF2-40B4-BE49-F238E27FC236}">
                            <a16:creationId xmlns:a16="http://schemas.microsoft.com/office/drawing/2014/main" id="{2E5130AA-1975-3B54-0813-139B42E6C83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470936" y="5991227"/>
                        <a:ext cx="4082599" cy="37682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Object 29">
            <a:extLst>
              <a:ext uri="{FF2B5EF4-FFF2-40B4-BE49-F238E27FC236}">
                <a16:creationId xmlns:a16="http://schemas.microsoft.com/office/drawing/2014/main" id="{436273FA-26F4-44CD-30F5-666FD246B1F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52002696"/>
              </p:ext>
            </p:extLst>
          </p:nvPr>
        </p:nvGraphicFramePr>
        <p:xfrm>
          <a:off x="5391307" y="6103521"/>
          <a:ext cx="3904958" cy="36042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8" imgW="2907376" imgH="2682711" progId="Prism10.Document">
                  <p:embed/>
                </p:oleObj>
              </mc:Choice>
              <mc:Fallback>
                <p:oleObj name="Prism" r:id="rId8" imgW="2907376" imgH="2682711" progId="Prism10.Document">
                  <p:embed/>
                  <p:pic>
                    <p:nvPicPr>
                      <p:cNvPr id="30" name="Object 29">
                        <a:extLst>
                          <a:ext uri="{FF2B5EF4-FFF2-40B4-BE49-F238E27FC236}">
                            <a16:creationId xmlns:a16="http://schemas.microsoft.com/office/drawing/2014/main" id="{436273FA-26F4-44CD-30F5-666FD246B1F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391307" y="6103521"/>
                        <a:ext cx="3904958" cy="360424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BFF688A2-B49F-9CF1-632D-EC5BB6CC29DD}"/>
              </a:ext>
            </a:extLst>
          </p:cNvPr>
          <p:cNvSpPr txBox="1"/>
          <p:nvPr/>
        </p:nvSpPr>
        <p:spPr>
          <a:xfrm>
            <a:off x="4506750" y="361815"/>
            <a:ext cx="317849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3200" b="1" dirty="0"/>
              <a:t>SUPPLEMENTAL</a:t>
            </a:r>
          </a:p>
        </p:txBody>
      </p:sp>
    </p:spTree>
    <p:extLst>
      <p:ext uri="{BB962C8B-B14F-4D97-AF65-F5344CB8AC3E}">
        <p14:creationId xmlns:p14="http://schemas.microsoft.com/office/powerpoint/2010/main" val="1524553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E3692340-D3C7-A6B8-73C4-70D19C429984}"/>
              </a:ext>
            </a:extLst>
          </p:cNvPr>
          <p:cNvSpPr txBox="1"/>
          <p:nvPr/>
        </p:nvSpPr>
        <p:spPr>
          <a:xfrm rot="16200000">
            <a:off x="-455622" y="2877153"/>
            <a:ext cx="1774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>
                <a:latin typeface="Arial" panose="020B0604020202020204" pitchFamily="34" charset="0"/>
                <a:cs typeface="Arial" panose="020B0604020202020204" pitchFamily="34" charset="0"/>
              </a:rPr>
              <a:t>Phenylephrin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FFE012F-1614-FB99-DBE6-B5E8AE65657A}"/>
              </a:ext>
            </a:extLst>
          </p:cNvPr>
          <p:cNvSpPr txBox="1"/>
          <p:nvPr/>
        </p:nvSpPr>
        <p:spPr>
          <a:xfrm rot="16200000">
            <a:off x="-340205" y="6108755"/>
            <a:ext cx="15440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>
                <a:latin typeface="Arial" panose="020B0604020202020204" pitchFamily="34" charset="0"/>
                <a:cs typeface="Arial" panose="020B0604020202020204" pitchFamily="34" charset="0"/>
              </a:rPr>
              <a:t>Isoprenalin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719B693-76F3-5084-FA3F-3FCB2A598EFF}"/>
              </a:ext>
            </a:extLst>
          </p:cNvPr>
          <p:cNvSpPr txBox="1"/>
          <p:nvPr/>
        </p:nvSpPr>
        <p:spPr>
          <a:xfrm rot="16200000">
            <a:off x="-344825" y="9163059"/>
            <a:ext cx="17363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>
                <a:latin typeface="Arial" panose="020B0604020202020204" pitchFamily="34" charset="0"/>
                <a:cs typeface="Arial" panose="020B0604020202020204" pitchFamily="34" charset="0"/>
              </a:rPr>
              <a:t>Noradrenalin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D8C2B54-E8CA-4FED-7959-D22F41103A6C}"/>
              </a:ext>
            </a:extLst>
          </p:cNvPr>
          <p:cNvSpPr txBox="1"/>
          <p:nvPr/>
        </p:nvSpPr>
        <p:spPr>
          <a:xfrm>
            <a:off x="4324496" y="512905"/>
            <a:ext cx="338208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3200" b="1" dirty="0"/>
              <a:t>SUPPLEMENTAL 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989B824-64C2-FF9D-E645-15AACF6381B4}"/>
              </a:ext>
            </a:extLst>
          </p:cNvPr>
          <p:cNvSpPr txBox="1"/>
          <p:nvPr/>
        </p:nvSpPr>
        <p:spPr>
          <a:xfrm>
            <a:off x="1258371" y="14440980"/>
            <a:ext cx="16706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S7.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2218684-F4FF-CB5F-6622-927C7CCE6588}"/>
              </a:ext>
            </a:extLst>
          </p:cNvPr>
          <p:cNvSpPr txBox="1"/>
          <p:nvPr/>
        </p:nvSpPr>
        <p:spPr>
          <a:xfrm>
            <a:off x="380827" y="1390345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1EA36F9-14A6-ADD2-2241-D98F5825D950}"/>
              </a:ext>
            </a:extLst>
          </p:cNvPr>
          <p:cNvSpPr txBox="1"/>
          <p:nvPr/>
        </p:nvSpPr>
        <p:spPr>
          <a:xfrm>
            <a:off x="412725" y="4765443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5B90443-9F17-5333-8CE0-56C346523523}"/>
              </a:ext>
            </a:extLst>
          </p:cNvPr>
          <p:cNvSpPr txBox="1"/>
          <p:nvPr/>
        </p:nvSpPr>
        <p:spPr>
          <a:xfrm>
            <a:off x="428990" y="7840946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id="{D62F9D92-08FD-43AC-297D-060454F9AE2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75522008"/>
              </p:ext>
            </p:extLst>
          </p:nvPr>
        </p:nvGraphicFramePr>
        <p:xfrm>
          <a:off x="436936" y="4953834"/>
          <a:ext cx="4443035" cy="30416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2" imgW="3870739" imgH="2649227" progId="Prism10.Document">
                  <p:embed/>
                </p:oleObj>
              </mc:Choice>
              <mc:Fallback>
                <p:oleObj name="Prism" r:id="rId2" imgW="3870739" imgH="2649227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36936" y="4953834"/>
                        <a:ext cx="4443035" cy="30416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id="{00EEC7ED-F25A-CF78-A927-05B7A762F0B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75927313"/>
              </p:ext>
            </p:extLst>
          </p:nvPr>
        </p:nvGraphicFramePr>
        <p:xfrm>
          <a:off x="4166080" y="4710113"/>
          <a:ext cx="4435475" cy="3311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4" imgW="3863176" imgH="2882177" progId="Prism10.Document">
                  <p:embed/>
                </p:oleObj>
              </mc:Choice>
              <mc:Fallback>
                <p:oleObj name="Prism" r:id="rId4" imgW="3863176" imgH="2882177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166080" y="4710113"/>
                        <a:ext cx="4435475" cy="3311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id="{1924E74A-6BB3-F9A1-028C-40D986A6018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3612023"/>
              </p:ext>
            </p:extLst>
          </p:nvPr>
        </p:nvGraphicFramePr>
        <p:xfrm>
          <a:off x="460889" y="1644475"/>
          <a:ext cx="4438546" cy="30335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6" imgW="3876861" imgH="2649227" progId="Prism10.Document">
                  <p:embed/>
                </p:oleObj>
              </mc:Choice>
              <mc:Fallback>
                <p:oleObj name="Prism" r:id="rId6" imgW="3876861" imgH="2649227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60889" y="1644475"/>
                        <a:ext cx="4438546" cy="30335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5C94FBA3-09FF-1F12-9674-8482859EFA0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40011603"/>
              </p:ext>
            </p:extLst>
          </p:nvPr>
        </p:nvGraphicFramePr>
        <p:xfrm>
          <a:off x="4221414" y="1711383"/>
          <a:ext cx="4368242" cy="30450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8" imgW="3878662" imgH="2703954" progId="Prism10.Document">
                  <p:embed/>
                </p:oleObj>
              </mc:Choice>
              <mc:Fallback>
                <p:oleObj name="Prism" r:id="rId8" imgW="3878662" imgH="2703954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221414" y="1711383"/>
                        <a:ext cx="4368242" cy="30450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ct 25">
            <a:extLst>
              <a:ext uri="{FF2B5EF4-FFF2-40B4-BE49-F238E27FC236}">
                <a16:creationId xmlns:a16="http://schemas.microsoft.com/office/drawing/2014/main" id="{3CE961A5-FB37-5009-AEFA-C85B928D678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10883855"/>
              </p:ext>
            </p:extLst>
          </p:nvPr>
        </p:nvGraphicFramePr>
        <p:xfrm>
          <a:off x="4317410" y="8131004"/>
          <a:ext cx="4410449" cy="28648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10" imgW="4575164" imgH="2972189" progId="Prism10.Document">
                  <p:embed/>
                </p:oleObj>
              </mc:Choice>
              <mc:Fallback>
                <p:oleObj name="Prism" r:id="rId10" imgW="4575164" imgH="2972189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317410" y="8131004"/>
                        <a:ext cx="4410449" cy="28648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bject 26">
            <a:extLst>
              <a:ext uri="{FF2B5EF4-FFF2-40B4-BE49-F238E27FC236}">
                <a16:creationId xmlns:a16="http://schemas.microsoft.com/office/drawing/2014/main" id="{21012523-2F9A-6105-3C75-42DCDCB674C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2780839"/>
              </p:ext>
            </p:extLst>
          </p:nvPr>
        </p:nvGraphicFramePr>
        <p:xfrm>
          <a:off x="615881" y="8003069"/>
          <a:ext cx="4410449" cy="30119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12" imgW="4656195" imgH="3179576" progId="Prism10.Document">
                  <p:embed/>
                </p:oleObj>
              </mc:Choice>
              <mc:Fallback>
                <p:oleObj name="Prism" r:id="rId12" imgW="4656195" imgH="317957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615881" y="8003069"/>
                        <a:ext cx="4410449" cy="30119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Object 27">
            <a:extLst>
              <a:ext uri="{FF2B5EF4-FFF2-40B4-BE49-F238E27FC236}">
                <a16:creationId xmlns:a16="http://schemas.microsoft.com/office/drawing/2014/main" id="{A561E64A-6E59-9D01-7FE0-E128E28A84A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76522574"/>
              </p:ext>
            </p:extLst>
          </p:nvPr>
        </p:nvGraphicFramePr>
        <p:xfrm>
          <a:off x="709391" y="10993058"/>
          <a:ext cx="4378107" cy="30119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14" imgW="3850931" imgH="2649227" progId="Prism10.Document">
                  <p:embed/>
                </p:oleObj>
              </mc:Choice>
              <mc:Fallback>
                <p:oleObj name="Prism" r:id="rId14" imgW="3850931" imgH="2649227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709391" y="10993058"/>
                        <a:ext cx="4378107" cy="30119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Object 28">
            <a:extLst>
              <a:ext uri="{FF2B5EF4-FFF2-40B4-BE49-F238E27FC236}">
                <a16:creationId xmlns:a16="http://schemas.microsoft.com/office/drawing/2014/main" id="{EF68FF53-238E-E7EF-C1C2-0AB0C84AEF6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26404502"/>
              </p:ext>
            </p:extLst>
          </p:nvPr>
        </p:nvGraphicFramePr>
        <p:xfrm>
          <a:off x="4575591" y="11117254"/>
          <a:ext cx="4136910" cy="28648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16" imgW="3850931" imgH="2667229" progId="Prism10.Document">
                  <p:embed/>
                </p:oleObj>
              </mc:Choice>
              <mc:Fallback>
                <p:oleObj name="Prism" r:id="rId16" imgW="3850931" imgH="2667229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4575591" y="11117254"/>
                        <a:ext cx="4136910" cy="286480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0" name="TextBox 29">
            <a:extLst>
              <a:ext uri="{FF2B5EF4-FFF2-40B4-BE49-F238E27FC236}">
                <a16:creationId xmlns:a16="http://schemas.microsoft.com/office/drawing/2014/main" id="{82B955EC-9F7C-A35B-3E6B-0C4600CB163B}"/>
              </a:ext>
            </a:extLst>
          </p:cNvPr>
          <p:cNvSpPr txBox="1"/>
          <p:nvPr/>
        </p:nvSpPr>
        <p:spPr>
          <a:xfrm rot="16200000">
            <a:off x="-589763" y="12285950"/>
            <a:ext cx="25955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>
                <a:latin typeface="Arial" panose="020B0604020202020204" pitchFamily="34" charset="0"/>
                <a:cs typeface="Arial" panose="020B0604020202020204" pitchFamily="34" charset="0"/>
              </a:rPr>
              <a:t>Sodium Nitroprussid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FB98F30-2D82-258F-CFEF-1B0BFAB22407}"/>
              </a:ext>
            </a:extLst>
          </p:cNvPr>
          <p:cNvSpPr txBox="1"/>
          <p:nvPr/>
        </p:nvSpPr>
        <p:spPr>
          <a:xfrm>
            <a:off x="426206" y="10852454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32" name="Object 31">
            <a:extLst>
              <a:ext uri="{FF2B5EF4-FFF2-40B4-BE49-F238E27FC236}">
                <a16:creationId xmlns:a16="http://schemas.microsoft.com/office/drawing/2014/main" id="{B337A0A1-0043-EAF3-C6DA-514C96FAD54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4403914"/>
              </p:ext>
            </p:extLst>
          </p:nvPr>
        </p:nvGraphicFramePr>
        <p:xfrm>
          <a:off x="7969808" y="4994441"/>
          <a:ext cx="4430155" cy="29808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18" imgW="3843368" imgH="2586579" progId="Prism10.Document">
                  <p:embed/>
                </p:oleObj>
              </mc:Choice>
              <mc:Fallback>
                <p:oleObj name="Prism" r:id="rId18" imgW="3843368" imgH="2586579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7969808" y="4994441"/>
                        <a:ext cx="4430155" cy="29808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Object 33">
            <a:extLst>
              <a:ext uri="{FF2B5EF4-FFF2-40B4-BE49-F238E27FC236}">
                <a16:creationId xmlns:a16="http://schemas.microsoft.com/office/drawing/2014/main" id="{F41D7B0A-F131-D544-46E2-6CEF2618085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70758530"/>
              </p:ext>
            </p:extLst>
          </p:nvPr>
        </p:nvGraphicFramePr>
        <p:xfrm>
          <a:off x="8108847" y="8032552"/>
          <a:ext cx="4249660" cy="29418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20" imgW="4611898" imgH="3191818" progId="Prism10.Document">
                  <p:embed/>
                </p:oleObj>
              </mc:Choice>
              <mc:Fallback>
                <p:oleObj name="Prism" r:id="rId20" imgW="4611898" imgH="3191818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8108847" y="8032552"/>
                        <a:ext cx="4249660" cy="294184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6" name="Object 35">
            <a:extLst>
              <a:ext uri="{FF2B5EF4-FFF2-40B4-BE49-F238E27FC236}">
                <a16:creationId xmlns:a16="http://schemas.microsoft.com/office/drawing/2014/main" id="{FF1D24B5-3A34-3F71-9FCF-5914276FF58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57884134"/>
              </p:ext>
            </p:extLst>
          </p:nvPr>
        </p:nvGraphicFramePr>
        <p:xfrm>
          <a:off x="7882755" y="1665072"/>
          <a:ext cx="4352741" cy="302899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22" imgW="3893787" imgH="2710075" progId="Prism10.Document">
                  <p:embed/>
                </p:oleObj>
              </mc:Choice>
              <mc:Fallback>
                <p:oleObj name="Prism" r:id="rId22" imgW="3893787" imgH="271007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7882755" y="1665072"/>
                        <a:ext cx="4352741" cy="302899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7" name="Object 36">
            <a:extLst>
              <a:ext uri="{FF2B5EF4-FFF2-40B4-BE49-F238E27FC236}">
                <a16:creationId xmlns:a16="http://schemas.microsoft.com/office/drawing/2014/main" id="{9517EBA2-1A0F-B0EA-7877-DC27483306C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17764518"/>
              </p:ext>
            </p:extLst>
          </p:nvPr>
        </p:nvGraphicFramePr>
        <p:xfrm>
          <a:off x="8134595" y="11067254"/>
          <a:ext cx="4287531" cy="28648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24" imgW="3870739" imgH="2586579" progId="Prism10.Document">
                  <p:embed/>
                </p:oleObj>
              </mc:Choice>
              <mc:Fallback>
                <p:oleObj name="Prism" r:id="rId24" imgW="3870739" imgH="2586579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8134595" y="11067254"/>
                        <a:ext cx="4287531" cy="28648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34243059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FBC03CD7-1966-4CD2-FB2D-F643E3F9B370}"/>
              </a:ext>
            </a:extLst>
          </p:cNvPr>
          <p:cNvSpPr txBox="1"/>
          <p:nvPr/>
        </p:nvSpPr>
        <p:spPr>
          <a:xfrm>
            <a:off x="7409355" y="179486"/>
            <a:ext cx="317849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3200" b="1" dirty="0"/>
              <a:t>SUPPLEMENTAL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E29AA56-8475-7C0D-68C5-5AF1326C305F}"/>
              </a:ext>
            </a:extLst>
          </p:cNvPr>
          <p:cNvSpPr txBox="1"/>
          <p:nvPr/>
        </p:nvSpPr>
        <p:spPr>
          <a:xfrm rot="16200000">
            <a:off x="-34892" y="1758796"/>
            <a:ext cx="1774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>
                <a:latin typeface="Arial" panose="020B0604020202020204" pitchFamily="34" charset="0"/>
                <a:cs typeface="Arial" panose="020B0604020202020204" pitchFamily="34" charset="0"/>
              </a:rPr>
              <a:t>Phenylephrin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55AF89C-714D-2225-3F6A-5DF451AFA5A9}"/>
              </a:ext>
            </a:extLst>
          </p:cNvPr>
          <p:cNvSpPr txBox="1"/>
          <p:nvPr/>
        </p:nvSpPr>
        <p:spPr>
          <a:xfrm rot="16200000">
            <a:off x="165146" y="5492929"/>
            <a:ext cx="15440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>
                <a:latin typeface="Arial" panose="020B0604020202020204" pitchFamily="34" charset="0"/>
                <a:cs typeface="Arial" panose="020B0604020202020204" pitchFamily="34" charset="0"/>
              </a:rPr>
              <a:t>Isoprenalin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BBFEDDA-1B46-B6B3-1224-941256B395FE}"/>
              </a:ext>
            </a:extLst>
          </p:cNvPr>
          <p:cNvSpPr txBox="1"/>
          <p:nvPr/>
        </p:nvSpPr>
        <p:spPr>
          <a:xfrm rot="16200000">
            <a:off x="84413" y="9112910"/>
            <a:ext cx="17363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>
                <a:latin typeface="Arial" panose="020B0604020202020204" pitchFamily="34" charset="0"/>
                <a:cs typeface="Arial" panose="020B0604020202020204" pitchFamily="34" charset="0"/>
              </a:rPr>
              <a:t>Noradrenalin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E8EF891-F885-935B-9B73-4D06D727CA4B}"/>
              </a:ext>
            </a:extLst>
          </p:cNvPr>
          <p:cNvSpPr txBox="1"/>
          <p:nvPr/>
        </p:nvSpPr>
        <p:spPr>
          <a:xfrm>
            <a:off x="604893" y="15560775"/>
            <a:ext cx="16706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S8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33D1203-4B8C-8E7A-C413-44A6C9359E68}"/>
              </a:ext>
            </a:extLst>
          </p:cNvPr>
          <p:cNvSpPr txBox="1"/>
          <p:nvPr/>
        </p:nvSpPr>
        <p:spPr>
          <a:xfrm>
            <a:off x="334835" y="339771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CC15B8D-F51A-2A92-3FF7-C250B4DF1560}"/>
              </a:ext>
            </a:extLst>
          </p:cNvPr>
          <p:cNvSpPr txBox="1"/>
          <p:nvPr/>
        </p:nvSpPr>
        <p:spPr>
          <a:xfrm>
            <a:off x="364342" y="4119891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FA605E9-F09D-D6F3-8DC7-5005D73DE541}"/>
              </a:ext>
            </a:extLst>
          </p:cNvPr>
          <p:cNvSpPr txBox="1"/>
          <p:nvPr/>
        </p:nvSpPr>
        <p:spPr>
          <a:xfrm>
            <a:off x="463683" y="7771213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54539AE8-E2D5-02E0-BEF2-43ED0D7BBA0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03881324"/>
              </p:ext>
            </p:extLst>
          </p:nvPr>
        </p:nvGraphicFramePr>
        <p:xfrm>
          <a:off x="1124403" y="218641"/>
          <a:ext cx="3419475" cy="3832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2" imgW="2937987" imgH="3292271" progId="Prism10.Document">
                  <p:embed/>
                </p:oleObj>
              </mc:Choice>
              <mc:Fallback>
                <p:oleObj name="Prism" r:id="rId2" imgW="2937987" imgH="3292271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124403" y="218641"/>
                        <a:ext cx="3419475" cy="3832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B7230B8E-F7C7-1AD5-B6B8-5A1D487FDE4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65048175"/>
              </p:ext>
            </p:extLst>
          </p:nvPr>
        </p:nvGraphicFramePr>
        <p:xfrm>
          <a:off x="4565114" y="564843"/>
          <a:ext cx="3419520" cy="35686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4" imgW="2948431" imgH="3077323" progId="Prism10.Document">
                  <p:embed/>
                </p:oleObj>
              </mc:Choice>
              <mc:Fallback>
                <p:oleObj name="Prism" r:id="rId4" imgW="2948431" imgH="3077323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565114" y="564843"/>
                        <a:ext cx="3419520" cy="35686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667EE6E0-FC84-1856-D247-5383609B212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8946637"/>
              </p:ext>
            </p:extLst>
          </p:nvPr>
        </p:nvGraphicFramePr>
        <p:xfrm>
          <a:off x="1006475" y="3973664"/>
          <a:ext cx="4548188" cy="37068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6" imgW="3872539" imgH="3156533" progId="Prism10.Document">
                  <p:embed/>
                </p:oleObj>
              </mc:Choice>
              <mc:Fallback>
                <p:oleObj name="Prism" r:id="rId6" imgW="3872539" imgH="3156533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006475" y="3973664"/>
                        <a:ext cx="4548188" cy="37068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>
            <a:extLst>
              <a:ext uri="{FF2B5EF4-FFF2-40B4-BE49-F238E27FC236}">
                <a16:creationId xmlns:a16="http://schemas.microsoft.com/office/drawing/2014/main" id="{6AE20CB0-A61C-F68D-9626-F3862CF6A66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49223642"/>
              </p:ext>
            </p:extLst>
          </p:nvPr>
        </p:nvGraphicFramePr>
        <p:xfrm>
          <a:off x="5471535" y="4092430"/>
          <a:ext cx="4541039" cy="36235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8" imgW="3864976" imgH="3084884" progId="Prism10.Document">
                  <p:embed/>
                </p:oleObj>
              </mc:Choice>
              <mc:Fallback>
                <p:oleObj name="Prism" r:id="rId8" imgW="3864976" imgH="3084884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471535" y="4092430"/>
                        <a:ext cx="4541039" cy="362350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ct 25">
            <a:extLst>
              <a:ext uri="{FF2B5EF4-FFF2-40B4-BE49-F238E27FC236}">
                <a16:creationId xmlns:a16="http://schemas.microsoft.com/office/drawing/2014/main" id="{0034B208-BCBC-6ABE-8A82-5455F9AB618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43689124"/>
              </p:ext>
            </p:extLst>
          </p:nvPr>
        </p:nvGraphicFramePr>
        <p:xfrm>
          <a:off x="5461913" y="8073680"/>
          <a:ext cx="4677752" cy="3747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10" imgW="3861735" imgH="3094245" progId="Prism10.Document">
                  <p:embed/>
                </p:oleObj>
              </mc:Choice>
              <mc:Fallback>
                <p:oleObj name="Prism" r:id="rId10" imgW="3861735" imgH="309424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5461913" y="8073680"/>
                        <a:ext cx="4677752" cy="3747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bject 26">
            <a:extLst>
              <a:ext uri="{FF2B5EF4-FFF2-40B4-BE49-F238E27FC236}">
                <a16:creationId xmlns:a16="http://schemas.microsoft.com/office/drawing/2014/main" id="{2F131F9D-3DB1-FDD8-0CF4-E158ACED736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26114694"/>
              </p:ext>
            </p:extLst>
          </p:nvPr>
        </p:nvGraphicFramePr>
        <p:xfrm>
          <a:off x="1218520" y="11790763"/>
          <a:ext cx="3408362" cy="3763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12" imgW="2975801" imgH="3286150" progId="Prism10.Document">
                  <p:embed/>
                </p:oleObj>
              </mc:Choice>
              <mc:Fallback>
                <p:oleObj name="Prism" r:id="rId12" imgW="2975801" imgH="3286150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218520" y="11790763"/>
                        <a:ext cx="3408362" cy="37639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Object 27">
            <a:extLst>
              <a:ext uri="{FF2B5EF4-FFF2-40B4-BE49-F238E27FC236}">
                <a16:creationId xmlns:a16="http://schemas.microsoft.com/office/drawing/2014/main" id="{81A8F272-9EF6-3979-BDF5-E913BB782BD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97701227"/>
              </p:ext>
            </p:extLst>
          </p:nvPr>
        </p:nvGraphicFramePr>
        <p:xfrm>
          <a:off x="4677330" y="12070029"/>
          <a:ext cx="3265967" cy="339963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14" imgW="2948431" imgH="3068322" progId="Prism10.Document">
                  <p:embed/>
                </p:oleObj>
              </mc:Choice>
              <mc:Fallback>
                <p:oleObj name="Prism" r:id="rId14" imgW="2948431" imgH="3068322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4677330" y="12070029"/>
                        <a:ext cx="3265967" cy="339963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0" name="TextBox 29">
            <a:extLst>
              <a:ext uri="{FF2B5EF4-FFF2-40B4-BE49-F238E27FC236}">
                <a16:creationId xmlns:a16="http://schemas.microsoft.com/office/drawing/2014/main" id="{A650B36F-F860-A75E-277A-EB1B17553679}"/>
              </a:ext>
            </a:extLst>
          </p:cNvPr>
          <p:cNvSpPr txBox="1"/>
          <p:nvPr/>
        </p:nvSpPr>
        <p:spPr>
          <a:xfrm>
            <a:off x="469227" y="11949216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0180DEF-9EE7-EBE6-8638-E342BB0178E3}"/>
              </a:ext>
            </a:extLst>
          </p:cNvPr>
          <p:cNvSpPr txBox="1"/>
          <p:nvPr/>
        </p:nvSpPr>
        <p:spPr>
          <a:xfrm rot="16200000">
            <a:off x="-279359" y="13291349"/>
            <a:ext cx="25955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>
                <a:latin typeface="Arial" panose="020B0604020202020204" pitchFamily="34" charset="0"/>
                <a:cs typeface="Arial" panose="020B0604020202020204" pitchFamily="34" charset="0"/>
              </a:rPr>
              <a:t>Sodium Nitroprusside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1BBC6EE6-E59C-1280-2571-1C710797217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9758161"/>
              </p:ext>
            </p:extLst>
          </p:nvPr>
        </p:nvGraphicFramePr>
        <p:xfrm>
          <a:off x="1046163" y="7611127"/>
          <a:ext cx="4792662" cy="4305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16" imgW="3852732" imgH="3460053" progId="Prism10.Document">
                  <p:embed/>
                </p:oleObj>
              </mc:Choice>
              <mc:Fallback>
                <p:oleObj name="Prism" r:id="rId16" imgW="3852732" imgH="3460053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1046163" y="7611127"/>
                        <a:ext cx="4792662" cy="43053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2955477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screenshot of a medical device&#10;&#10;AI-generated content may be incorrect.">
            <a:extLst>
              <a:ext uri="{FF2B5EF4-FFF2-40B4-BE49-F238E27FC236}">
                <a16:creationId xmlns:a16="http://schemas.microsoft.com/office/drawing/2014/main" id="{E2358BB3-6DCF-E7A8-4AC1-8D688F7BFC6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1085" y="5260380"/>
            <a:ext cx="4712372" cy="3534278"/>
          </a:xfrm>
          <a:prstGeom prst="rect">
            <a:avLst/>
          </a:prstGeom>
        </p:spPr>
      </p:pic>
      <p:pic>
        <p:nvPicPr>
          <p:cNvPr id="3" name="Picture 2" descr="A screenshot of a medical scan&#10;&#10;AI-generated content may be incorrect.">
            <a:extLst>
              <a:ext uri="{FF2B5EF4-FFF2-40B4-BE49-F238E27FC236}">
                <a16:creationId xmlns:a16="http://schemas.microsoft.com/office/drawing/2014/main" id="{C387D76B-F593-FC6D-4988-6667516E115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245"/>
          <a:stretch>
            <a:fillRect/>
          </a:stretch>
        </p:blipFill>
        <p:spPr>
          <a:xfrm>
            <a:off x="851085" y="1239876"/>
            <a:ext cx="4712373" cy="3242872"/>
          </a:xfrm>
          <a:prstGeom prst="rect">
            <a:avLst/>
          </a:prstGeom>
        </p:spPr>
      </p:pic>
      <p:pic>
        <p:nvPicPr>
          <p:cNvPr id="4" name="Picture 3" descr="A screenshot of a computer screen&#10;&#10;AI-generated content may be incorrect.">
            <a:extLst>
              <a:ext uri="{FF2B5EF4-FFF2-40B4-BE49-F238E27FC236}">
                <a16:creationId xmlns:a16="http://schemas.microsoft.com/office/drawing/2014/main" id="{18251488-FF6C-6200-65A3-BC0A1EDAA3E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1670" y="9572290"/>
            <a:ext cx="4712371" cy="3534278"/>
          </a:xfrm>
          <a:prstGeom prst="rect">
            <a:avLst/>
          </a:prstGeom>
        </p:spPr>
      </p:pic>
      <p:pic>
        <p:nvPicPr>
          <p:cNvPr id="5" name="Picture 4" descr="A screenshot of a computer screen&#10;&#10;AI-generated content may be incorrect.">
            <a:extLst>
              <a:ext uri="{FF2B5EF4-FFF2-40B4-BE49-F238E27FC236}">
                <a16:creationId xmlns:a16="http://schemas.microsoft.com/office/drawing/2014/main" id="{0FB7FE11-8DD8-7C6F-D48E-BBE62E9AD68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14853" y="9572290"/>
            <a:ext cx="4712371" cy="353427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C406825-8FF6-6FF9-C9CC-05D94CA8F27E}"/>
              </a:ext>
            </a:extLst>
          </p:cNvPr>
          <p:cNvSpPr txBox="1"/>
          <p:nvPr/>
        </p:nvSpPr>
        <p:spPr>
          <a:xfrm>
            <a:off x="1056344" y="14723736"/>
            <a:ext cx="200849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3200" b="1" dirty="0"/>
              <a:t>Figure S9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22D42AC-CB48-6AA5-4F4A-F8C9B7F055E0}"/>
              </a:ext>
            </a:extLst>
          </p:cNvPr>
          <p:cNvSpPr txBox="1"/>
          <p:nvPr/>
        </p:nvSpPr>
        <p:spPr>
          <a:xfrm>
            <a:off x="648860" y="625932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390DDAE-83EF-08E6-5BE0-BCC10D11DF5D}"/>
              </a:ext>
            </a:extLst>
          </p:cNvPr>
          <p:cNvSpPr txBox="1"/>
          <p:nvPr/>
        </p:nvSpPr>
        <p:spPr>
          <a:xfrm>
            <a:off x="445118" y="4798715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6EADBC6-34FE-A04C-9999-BE50E525974E}"/>
              </a:ext>
            </a:extLst>
          </p:cNvPr>
          <p:cNvSpPr txBox="1"/>
          <p:nvPr/>
        </p:nvSpPr>
        <p:spPr>
          <a:xfrm>
            <a:off x="444185" y="9110625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2BE05D9-DE42-4A96-573A-819E3564E4B0}"/>
              </a:ext>
            </a:extLst>
          </p:cNvPr>
          <p:cNvSpPr txBox="1"/>
          <p:nvPr/>
        </p:nvSpPr>
        <p:spPr>
          <a:xfrm>
            <a:off x="4703444" y="365262"/>
            <a:ext cx="317849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3200" b="1" dirty="0"/>
              <a:t>SUPPLEMENTAL</a:t>
            </a:r>
          </a:p>
        </p:txBody>
      </p:sp>
    </p:spTree>
    <p:extLst>
      <p:ext uri="{BB962C8B-B14F-4D97-AF65-F5344CB8AC3E}">
        <p14:creationId xmlns:p14="http://schemas.microsoft.com/office/powerpoint/2010/main" val="17557784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463</TotalTime>
  <Words>87</Words>
  <Application>Microsoft Office PowerPoint</Application>
  <PresentationFormat>Custom</PresentationFormat>
  <Paragraphs>66</Paragraphs>
  <Slides>9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ptos</vt:lpstr>
      <vt:lpstr>Aptos Display</vt:lpstr>
      <vt:lpstr>Arial</vt:lpstr>
      <vt:lpstr>Office Theme</vt:lpstr>
      <vt:lpstr>Prism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ennie Vu</dc:creator>
  <cp:lastModifiedBy>Jennie Vu</cp:lastModifiedBy>
  <cp:revision>104</cp:revision>
  <dcterms:created xsi:type="dcterms:W3CDTF">2025-09-15T00:51:30Z</dcterms:created>
  <dcterms:modified xsi:type="dcterms:W3CDTF">2026-05-24T15:27:37Z</dcterms:modified>
</cp:coreProperties>
</file>